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668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874096-B467-4887-8A9F-F7653EB60D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F4D75A1-B582-433F-A9BB-F9BAA9B514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83CB70-9D3E-4C1D-860E-161B7DD3C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32315-18E4-468E-AF6B-B6214E991E6D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67122B-7D76-4E75-9B85-50F085DCE8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A68E0F-3F07-4E5C-B561-5095101C1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1053A-424A-4714-93BF-085A03044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248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DAF9C5-00AD-464F-8E34-C15AB89681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8366F6-0936-416C-A8CC-C47036347A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AFC58B-3F98-4220-A72A-02AAE5C48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32315-18E4-468E-AF6B-B6214E991E6D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E1B303-965E-4F2A-9AA7-65C1B6C75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3E54C3-81D3-4389-A928-6F9D7AC657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1053A-424A-4714-93BF-085A03044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793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534B7D8-5811-419B-AA66-777F7C6452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8F443D-7271-4C25-9610-3D5012E820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0454FD-2A33-498E-838F-211496081E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32315-18E4-468E-AF6B-B6214E991E6D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8B5B21-9381-494D-8868-7615E798F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199761-B4BF-443F-91F8-0B05D437F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1053A-424A-4714-93BF-085A03044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333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A807FC-EAFA-4002-98F9-625FA49804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08EE38-7BFF-416C-8BB5-9AACD193FE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7FB518-D746-41DC-A6CC-9C077D48C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32315-18E4-468E-AF6B-B6214E991E6D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174B5A-BEFA-44FF-8E9F-90CA29A24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90AA71-B7C9-4DAE-9AE8-F100211E1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1053A-424A-4714-93BF-085A03044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00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E8622B-B55C-4DAC-B77C-E63C795C60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361C95-ED31-40A0-A9C0-8B000FA933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B3B139-91B6-40EF-B6EA-6BCB53CEF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32315-18E4-468E-AF6B-B6214E991E6D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41E717-FB7D-49ED-9792-8535F8433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1596F1-9839-4ADE-9E45-BEF4CF2FE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1053A-424A-4714-93BF-085A03044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928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AE6B52-1536-456B-A997-E209C3C85A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9972D0-260A-48A0-9D0C-1BCC754D9D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0404CD-7039-4B36-A9CC-AA6BC906CA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8D6615-5D09-48F8-9B60-7978FCFC8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32315-18E4-468E-AF6B-B6214E991E6D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EBFCB7-02B4-4722-9BBF-45E5F3F09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4B6BC4-E1D8-4E4A-BFE9-F457D7F6A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1053A-424A-4714-93BF-085A03044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696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52F8CF-036A-4CBC-9390-C5D349C646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2D31EA-2992-4F16-BA1F-FDF30DE638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795B8E-3063-4A3D-9873-6BCE4A68B8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48A5D74-F6FA-4B6E-96D4-08ABD867D3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8D7633-A24A-437D-B595-D09460436C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E9730D-0206-4906-B9F2-5A6E79466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32315-18E4-468E-AF6B-B6214E991E6D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5809727-D4B7-4832-8AD5-9B376AB01A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22A7C5C-87D3-4BD3-97FB-F0A05AABF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1053A-424A-4714-93BF-085A03044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00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CE089-D1AD-46A2-959E-1EA966630F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8D156E2-C808-4535-98BC-30C29360F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32315-18E4-468E-AF6B-B6214E991E6D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EE2B22B-24E0-4899-BE4A-22212E88C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3A0C2C-DE26-4E39-A4E8-467A8A65C1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1053A-424A-4714-93BF-085A03044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419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E212501-28D6-4DBE-87D8-6A4F92136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32315-18E4-468E-AF6B-B6214E991E6D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222E8A-36EE-43A2-A141-E0ACFDAAE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CBDFEC-2FC3-41F7-AB3E-7A42DFB24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1053A-424A-4714-93BF-085A03044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574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ED0EA-1728-4B6F-B855-1AB8D679DF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6F35B5-267F-419F-8C3D-651ADD8F22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563AC3-CD88-4185-BC4E-B7FA6A2B22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CB98C1-DE4A-4A76-BD5B-44ED376D45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32315-18E4-468E-AF6B-B6214E991E6D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4ECFE5-A100-408D-B63A-BB1FB3CC68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303D9B-92E0-41AE-8B9A-F9C37C39F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1053A-424A-4714-93BF-085A03044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1859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6835B4-5548-4373-8987-E7B2D1C76C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00C4B5D-5286-4516-AB1B-12540E61E1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5A665D-EEA9-410E-A228-1A20E6958D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C8EF39-4E02-486D-8923-0E86AEBE96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32315-18E4-468E-AF6B-B6214E991E6D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712885-72AC-4E6C-98D3-226B049BB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662B0A-EEC6-4F4F-ACD9-BCA4FB4AC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1053A-424A-4714-93BF-085A03044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422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DA8BE11-FBB9-4A39-A806-59B0E8E6D4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24C1DA-0881-46A4-A505-2669D39B53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0258C5-0A23-45FC-A5E4-F3E86F6B52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E32315-18E4-468E-AF6B-B6214E991E6D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90BA9C-0096-4D5F-B2F9-218BFF709A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834FAD-C062-4445-99B9-F7D9964FA9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01053A-424A-4714-93BF-085A03044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521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32C9AAEC-1F10-41ED-B7DD-C646A38276E0}"/>
              </a:ext>
            </a:extLst>
          </p:cNvPr>
          <p:cNvSpPr/>
          <p:nvPr/>
        </p:nvSpPr>
        <p:spPr>
          <a:xfrm>
            <a:off x="4181372" y="1750985"/>
            <a:ext cx="1644308" cy="81814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ycerol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3F470EFE-C2AA-42D2-9274-2E7994CA9493}"/>
              </a:ext>
            </a:extLst>
          </p:cNvPr>
          <p:cNvSpPr/>
          <p:nvPr/>
        </p:nvSpPr>
        <p:spPr>
          <a:xfrm>
            <a:off x="8945873" y="1760610"/>
            <a:ext cx="1644308" cy="81814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rch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D321D0E5-AEE9-41E0-84DF-6521C82EFD38}"/>
              </a:ext>
            </a:extLst>
          </p:cNvPr>
          <p:cNvSpPr/>
          <p:nvPr/>
        </p:nvSpPr>
        <p:spPr>
          <a:xfrm>
            <a:off x="2997461" y="3279797"/>
            <a:ext cx="1644308" cy="81814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uartz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B298D43F-C094-4DD0-8BF3-4831F3DDDF90}"/>
              </a:ext>
            </a:extLst>
          </p:cNvPr>
          <p:cNvSpPr/>
          <p:nvPr/>
        </p:nvSpPr>
        <p:spPr>
          <a:xfrm>
            <a:off x="5297903" y="3279798"/>
            <a:ext cx="1644308" cy="81814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quartz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: Rounded Corners 9">
            <a:extLst>
              <a:ext uri="{FF2B5EF4-FFF2-40B4-BE49-F238E27FC236}">
                <a16:creationId xmlns:a16="http://schemas.microsoft.com/office/drawing/2014/main" id="{101B6747-00D9-45BE-9776-D9BA32779AB5}"/>
              </a:ext>
            </a:extLst>
          </p:cNvPr>
          <p:cNvSpPr/>
          <p:nvPr/>
        </p:nvSpPr>
        <p:spPr>
          <a:xfrm>
            <a:off x="7781218" y="3289422"/>
            <a:ext cx="1644308" cy="81814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uartz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FD229CC3-4EE8-45EE-8876-3BA704335F92}"/>
              </a:ext>
            </a:extLst>
          </p:cNvPr>
          <p:cNvSpPr/>
          <p:nvPr/>
        </p:nvSpPr>
        <p:spPr>
          <a:xfrm>
            <a:off x="10081660" y="3289422"/>
            <a:ext cx="1644308" cy="81814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quartz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: Rounded Corners 11">
            <a:extLst>
              <a:ext uri="{FF2B5EF4-FFF2-40B4-BE49-F238E27FC236}">
                <a16:creationId xmlns:a16="http://schemas.microsoft.com/office/drawing/2014/main" id="{5E75C955-19EE-490A-92A8-0264D5C27AFA}"/>
              </a:ext>
            </a:extLst>
          </p:cNvPr>
          <p:cNvSpPr/>
          <p:nvPr/>
        </p:nvSpPr>
        <p:spPr>
          <a:xfrm>
            <a:off x="3036762" y="4462912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: Rounded Corners 12">
            <a:extLst>
              <a:ext uri="{FF2B5EF4-FFF2-40B4-BE49-F238E27FC236}">
                <a16:creationId xmlns:a16="http://schemas.microsoft.com/office/drawing/2014/main" id="{0C4D29E3-9135-419B-91DF-9A80254D218E}"/>
              </a:ext>
            </a:extLst>
          </p:cNvPr>
          <p:cNvSpPr/>
          <p:nvPr/>
        </p:nvSpPr>
        <p:spPr>
          <a:xfrm>
            <a:off x="3858115" y="4462912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: Rounded Corners 13">
            <a:extLst>
              <a:ext uri="{FF2B5EF4-FFF2-40B4-BE49-F238E27FC236}">
                <a16:creationId xmlns:a16="http://schemas.microsoft.com/office/drawing/2014/main" id="{67A48587-24EA-4D1F-AD4F-908D8B55DEAD}"/>
              </a:ext>
            </a:extLst>
          </p:cNvPr>
          <p:cNvSpPr/>
          <p:nvPr/>
        </p:nvSpPr>
        <p:spPr>
          <a:xfrm>
            <a:off x="3036761" y="5250579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857E3F42-7CF6-4A05-9638-868398556703}"/>
              </a:ext>
            </a:extLst>
          </p:cNvPr>
          <p:cNvSpPr/>
          <p:nvPr/>
        </p:nvSpPr>
        <p:spPr>
          <a:xfrm>
            <a:off x="3858115" y="5250578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: Rounded Corners 15">
            <a:extLst>
              <a:ext uri="{FF2B5EF4-FFF2-40B4-BE49-F238E27FC236}">
                <a16:creationId xmlns:a16="http://schemas.microsoft.com/office/drawing/2014/main" id="{D3FA4D17-FA05-49DB-8F2F-2350970F4664}"/>
              </a:ext>
            </a:extLst>
          </p:cNvPr>
          <p:cNvSpPr/>
          <p:nvPr/>
        </p:nvSpPr>
        <p:spPr>
          <a:xfrm>
            <a:off x="5338801" y="4462912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: Rounded Corners 16">
            <a:extLst>
              <a:ext uri="{FF2B5EF4-FFF2-40B4-BE49-F238E27FC236}">
                <a16:creationId xmlns:a16="http://schemas.microsoft.com/office/drawing/2014/main" id="{6E5B865F-98A8-47C9-9AF4-946F9EE92C04}"/>
              </a:ext>
            </a:extLst>
          </p:cNvPr>
          <p:cNvSpPr/>
          <p:nvPr/>
        </p:nvSpPr>
        <p:spPr>
          <a:xfrm>
            <a:off x="6160154" y="4462912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: Rounded Corners 17">
            <a:extLst>
              <a:ext uri="{FF2B5EF4-FFF2-40B4-BE49-F238E27FC236}">
                <a16:creationId xmlns:a16="http://schemas.microsoft.com/office/drawing/2014/main" id="{C7F3E6D3-3913-4891-BDCC-FB258F01F699}"/>
              </a:ext>
            </a:extLst>
          </p:cNvPr>
          <p:cNvSpPr/>
          <p:nvPr/>
        </p:nvSpPr>
        <p:spPr>
          <a:xfrm>
            <a:off x="5338800" y="5250579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: Rounded Corners 18">
            <a:extLst>
              <a:ext uri="{FF2B5EF4-FFF2-40B4-BE49-F238E27FC236}">
                <a16:creationId xmlns:a16="http://schemas.microsoft.com/office/drawing/2014/main" id="{8AE45437-B14B-493C-96C2-06ECBBC415A6}"/>
              </a:ext>
            </a:extLst>
          </p:cNvPr>
          <p:cNvSpPr/>
          <p:nvPr/>
        </p:nvSpPr>
        <p:spPr>
          <a:xfrm>
            <a:off x="6160154" y="5250578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: Rounded Corners 19">
            <a:extLst>
              <a:ext uri="{FF2B5EF4-FFF2-40B4-BE49-F238E27FC236}">
                <a16:creationId xmlns:a16="http://schemas.microsoft.com/office/drawing/2014/main" id="{1DB8D12D-4BE4-467D-AA6F-7038D043A4A2}"/>
              </a:ext>
            </a:extLst>
          </p:cNvPr>
          <p:cNvSpPr/>
          <p:nvPr/>
        </p:nvSpPr>
        <p:spPr>
          <a:xfrm>
            <a:off x="7847788" y="4472536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: Rounded Corners 20">
            <a:extLst>
              <a:ext uri="{FF2B5EF4-FFF2-40B4-BE49-F238E27FC236}">
                <a16:creationId xmlns:a16="http://schemas.microsoft.com/office/drawing/2014/main" id="{EAA2114E-4B41-4F62-ACD3-EDF4BE6B08F1}"/>
              </a:ext>
            </a:extLst>
          </p:cNvPr>
          <p:cNvSpPr/>
          <p:nvPr/>
        </p:nvSpPr>
        <p:spPr>
          <a:xfrm>
            <a:off x="8669141" y="4472536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: Rounded Corners 21">
            <a:extLst>
              <a:ext uri="{FF2B5EF4-FFF2-40B4-BE49-F238E27FC236}">
                <a16:creationId xmlns:a16="http://schemas.microsoft.com/office/drawing/2014/main" id="{B7B36BEE-EE69-41B0-9D0D-C9B87B8B52C9}"/>
              </a:ext>
            </a:extLst>
          </p:cNvPr>
          <p:cNvSpPr/>
          <p:nvPr/>
        </p:nvSpPr>
        <p:spPr>
          <a:xfrm>
            <a:off x="7847787" y="5260203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: Rounded Corners 22">
            <a:extLst>
              <a:ext uri="{FF2B5EF4-FFF2-40B4-BE49-F238E27FC236}">
                <a16:creationId xmlns:a16="http://schemas.microsoft.com/office/drawing/2014/main" id="{DB5ECBDE-2589-483F-AE4B-B160C2AB778F}"/>
              </a:ext>
            </a:extLst>
          </p:cNvPr>
          <p:cNvSpPr/>
          <p:nvPr/>
        </p:nvSpPr>
        <p:spPr>
          <a:xfrm>
            <a:off x="8669141" y="5260202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Rectangle: Rounded Corners 23">
            <a:extLst>
              <a:ext uri="{FF2B5EF4-FFF2-40B4-BE49-F238E27FC236}">
                <a16:creationId xmlns:a16="http://schemas.microsoft.com/office/drawing/2014/main" id="{C7C8EDD2-2FC8-45D8-96E5-897005A5A9A5}"/>
              </a:ext>
            </a:extLst>
          </p:cNvPr>
          <p:cNvSpPr/>
          <p:nvPr/>
        </p:nvSpPr>
        <p:spPr>
          <a:xfrm>
            <a:off x="10149827" y="4472536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angle: Rounded Corners 24">
            <a:extLst>
              <a:ext uri="{FF2B5EF4-FFF2-40B4-BE49-F238E27FC236}">
                <a16:creationId xmlns:a16="http://schemas.microsoft.com/office/drawing/2014/main" id="{86CBB485-742E-48C1-80F9-6E292F3C6ED5}"/>
              </a:ext>
            </a:extLst>
          </p:cNvPr>
          <p:cNvSpPr/>
          <p:nvPr/>
        </p:nvSpPr>
        <p:spPr>
          <a:xfrm>
            <a:off x="10971180" y="4472536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: Rounded Corners 25">
            <a:extLst>
              <a:ext uri="{FF2B5EF4-FFF2-40B4-BE49-F238E27FC236}">
                <a16:creationId xmlns:a16="http://schemas.microsoft.com/office/drawing/2014/main" id="{7B73536F-A0D9-49A5-9548-BA0DA17AE93C}"/>
              </a:ext>
            </a:extLst>
          </p:cNvPr>
          <p:cNvSpPr/>
          <p:nvPr/>
        </p:nvSpPr>
        <p:spPr>
          <a:xfrm>
            <a:off x="10149826" y="5260203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ectangle: Rounded Corners 26">
            <a:extLst>
              <a:ext uri="{FF2B5EF4-FFF2-40B4-BE49-F238E27FC236}">
                <a16:creationId xmlns:a16="http://schemas.microsoft.com/office/drawing/2014/main" id="{DD26DEED-CBFD-48D2-90B6-A1C37E349256}"/>
              </a:ext>
            </a:extLst>
          </p:cNvPr>
          <p:cNvSpPr/>
          <p:nvPr/>
        </p:nvSpPr>
        <p:spPr>
          <a:xfrm>
            <a:off x="10971180" y="5260202"/>
            <a:ext cx="725115" cy="638477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Connector: Elbow 28">
            <a:extLst>
              <a:ext uri="{FF2B5EF4-FFF2-40B4-BE49-F238E27FC236}">
                <a16:creationId xmlns:a16="http://schemas.microsoft.com/office/drawing/2014/main" id="{6582B699-D3E4-4D12-B938-09686FDB7871}"/>
              </a:ext>
            </a:extLst>
          </p:cNvPr>
          <p:cNvCxnSpPr>
            <a:stCxn id="6" idx="2"/>
            <a:endCxn id="9" idx="0"/>
          </p:cNvCxnSpPr>
          <p:nvPr/>
        </p:nvCxnSpPr>
        <p:spPr>
          <a:xfrm rot="16200000" flipH="1">
            <a:off x="5206458" y="2366199"/>
            <a:ext cx="710666" cy="1116531"/>
          </a:xfrm>
          <a:prstGeom prst="bentConnector3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Connector: Elbow 30">
            <a:extLst>
              <a:ext uri="{FF2B5EF4-FFF2-40B4-BE49-F238E27FC236}">
                <a16:creationId xmlns:a16="http://schemas.microsoft.com/office/drawing/2014/main" id="{69AB90E5-99BD-4924-8DB0-91383BFDAB54}"/>
              </a:ext>
            </a:extLst>
          </p:cNvPr>
          <p:cNvCxnSpPr>
            <a:stCxn id="6" idx="2"/>
            <a:endCxn id="8" idx="0"/>
          </p:cNvCxnSpPr>
          <p:nvPr/>
        </p:nvCxnSpPr>
        <p:spPr>
          <a:xfrm rot="5400000">
            <a:off x="4056239" y="2332509"/>
            <a:ext cx="710665" cy="1183911"/>
          </a:xfrm>
          <a:prstGeom prst="bentConnector3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Connector: Elbow 31">
            <a:extLst>
              <a:ext uri="{FF2B5EF4-FFF2-40B4-BE49-F238E27FC236}">
                <a16:creationId xmlns:a16="http://schemas.microsoft.com/office/drawing/2014/main" id="{68D80523-A09A-46F2-8B8F-B1A12292F908}"/>
              </a:ext>
            </a:extLst>
          </p:cNvPr>
          <p:cNvCxnSpPr>
            <a:cxnSpLocks/>
            <a:stCxn id="7" idx="2"/>
            <a:endCxn id="11" idx="0"/>
          </p:cNvCxnSpPr>
          <p:nvPr/>
        </p:nvCxnSpPr>
        <p:spPr>
          <a:xfrm rot="16200000" flipH="1">
            <a:off x="9980588" y="2366195"/>
            <a:ext cx="710665" cy="1135787"/>
          </a:xfrm>
          <a:prstGeom prst="bentConnector3">
            <a:avLst>
              <a:gd name="adj1" fmla="val 50000"/>
            </a:avLst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Connector: Elbow 32">
            <a:extLst>
              <a:ext uri="{FF2B5EF4-FFF2-40B4-BE49-F238E27FC236}">
                <a16:creationId xmlns:a16="http://schemas.microsoft.com/office/drawing/2014/main" id="{39853B08-CA7F-4DF0-9AC7-FF5966F9460C}"/>
              </a:ext>
            </a:extLst>
          </p:cNvPr>
          <p:cNvCxnSpPr>
            <a:cxnSpLocks/>
            <a:stCxn id="7" idx="2"/>
            <a:endCxn id="10" idx="0"/>
          </p:cNvCxnSpPr>
          <p:nvPr/>
        </p:nvCxnSpPr>
        <p:spPr>
          <a:xfrm rot="5400000">
            <a:off x="8830368" y="2351762"/>
            <a:ext cx="710665" cy="1164655"/>
          </a:xfrm>
          <a:prstGeom prst="bentConnector3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Right Bracket 37">
            <a:extLst>
              <a:ext uri="{FF2B5EF4-FFF2-40B4-BE49-F238E27FC236}">
                <a16:creationId xmlns:a16="http://schemas.microsoft.com/office/drawing/2014/main" id="{B643AEA7-C9D3-4038-9EC0-2FB65B51D1E9}"/>
              </a:ext>
            </a:extLst>
          </p:cNvPr>
          <p:cNvSpPr/>
          <p:nvPr/>
        </p:nvSpPr>
        <p:spPr>
          <a:xfrm rot="16200000">
            <a:off x="3771496" y="3611080"/>
            <a:ext cx="96238" cy="1491916"/>
          </a:xfrm>
          <a:prstGeom prst="rightBracket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9480E6EA-D509-41A8-A6EA-B3B0CAE6FFCF}"/>
              </a:ext>
            </a:extLst>
          </p:cNvPr>
          <p:cNvCxnSpPr>
            <a:cxnSpLocks/>
            <a:stCxn id="8" idx="2"/>
            <a:endCxn id="38" idx="2"/>
          </p:cNvCxnSpPr>
          <p:nvPr/>
        </p:nvCxnSpPr>
        <p:spPr>
          <a:xfrm>
            <a:off x="3819615" y="4097944"/>
            <a:ext cx="0" cy="210975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Right Bracket 40">
            <a:extLst>
              <a:ext uri="{FF2B5EF4-FFF2-40B4-BE49-F238E27FC236}">
                <a16:creationId xmlns:a16="http://schemas.microsoft.com/office/drawing/2014/main" id="{525EE083-7920-4799-A534-468C99D2146E}"/>
              </a:ext>
            </a:extLst>
          </p:cNvPr>
          <p:cNvSpPr/>
          <p:nvPr/>
        </p:nvSpPr>
        <p:spPr>
          <a:xfrm rot="16200000">
            <a:off x="6108827" y="3619089"/>
            <a:ext cx="96238" cy="1491916"/>
          </a:xfrm>
          <a:prstGeom prst="rightBracket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C1AAA1F-DAF4-4A80-BF52-E32D4FCE89CE}"/>
              </a:ext>
            </a:extLst>
          </p:cNvPr>
          <p:cNvCxnSpPr>
            <a:endCxn id="41" idx="2"/>
          </p:cNvCxnSpPr>
          <p:nvPr/>
        </p:nvCxnSpPr>
        <p:spPr>
          <a:xfrm flipH="1">
            <a:off x="6156946" y="4077892"/>
            <a:ext cx="1" cy="23903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Right Bracket 47">
            <a:extLst>
              <a:ext uri="{FF2B5EF4-FFF2-40B4-BE49-F238E27FC236}">
                <a16:creationId xmlns:a16="http://schemas.microsoft.com/office/drawing/2014/main" id="{2F6155D0-4E36-4135-B21F-B66AC8A44C66}"/>
              </a:ext>
            </a:extLst>
          </p:cNvPr>
          <p:cNvSpPr/>
          <p:nvPr/>
        </p:nvSpPr>
        <p:spPr>
          <a:xfrm rot="16200000">
            <a:off x="8582512" y="3636743"/>
            <a:ext cx="96238" cy="1491916"/>
          </a:xfrm>
          <a:prstGeom prst="rightBracket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3BCA412E-A3A9-40C5-B7F6-7640BED5B619}"/>
              </a:ext>
            </a:extLst>
          </p:cNvPr>
          <p:cNvCxnSpPr>
            <a:endCxn id="48" idx="2"/>
          </p:cNvCxnSpPr>
          <p:nvPr/>
        </p:nvCxnSpPr>
        <p:spPr>
          <a:xfrm flipH="1">
            <a:off x="8630631" y="4095546"/>
            <a:ext cx="1" cy="23903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Right Bracket 51">
            <a:extLst>
              <a:ext uri="{FF2B5EF4-FFF2-40B4-BE49-F238E27FC236}">
                <a16:creationId xmlns:a16="http://schemas.microsoft.com/office/drawing/2014/main" id="{87ADED3F-BB27-421C-828C-FD14F0A0CF9C}"/>
              </a:ext>
            </a:extLst>
          </p:cNvPr>
          <p:cNvSpPr/>
          <p:nvPr/>
        </p:nvSpPr>
        <p:spPr>
          <a:xfrm rot="16200000">
            <a:off x="10881339" y="3627924"/>
            <a:ext cx="96238" cy="1491916"/>
          </a:xfrm>
          <a:prstGeom prst="rightBracket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607F9A96-B41F-4F6B-8ABC-39E9B561BB16}"/>
              </a:ext>
            </a:extLst>
          </p:cNvPr>
          <p:cNvCxnSpPr>
            <a:endCxn id="52" idx="2"/>
          </p:cNvCxnSpPr>
          <p:nvPr/>
        </p:nvCxnSpPr>
        <p:spPr>
          <a:xfrm flipH="1">
            <a:off x="10929458" y="4086727"/>
            <a:ext cx="1" cy="23903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99697369-B779-41FC-8D06-9C6A0EF5393C}"/>
              </a:ext>
            </a:extLst>
          </p:cNvPr>
          <p:cNvSpPr txBox="1"/>
          <p:nvPr/>
        </p:nvSpPr>
        <p:spPr>
          <a:xfrm>
            <a:off x="309609" y="1929225"/>
            <a:ext cx="30897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trate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9C561C26-4CAC-41E8-AE6A-0E50E0612915}"/>
              </a:ext>
            </a:extLst>
          </p:cNvPr>
          <p:cNvSpPr txBox="1"/>
          <p:nvPr/>
        </p:nvSpPr>
        <p:spPr>
          <a:xfrm>
            <a:off x="309608" y="3467662"/>
            <a:ext cx="30897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rix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8BC16CAC-9480-45FF-8543-DDDA9BA0A252}"/>
              </a:ext>
            </a:extLst>
          </p:cNvPr>
          <p:cNvSpPr txBox="1"/>
          <p:nvPr/>
        </p:nvSpPr>
        <p:spPr>
          <a:xfrm>
            <a:off x="309607" y="4870556"/>
            <a:ext cx="30897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licates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Rectangle: Rounded Corners 82">
            <a:extLst>
              <a:ext uri="{FF2B5EF4-FFF2-40B4-BE49-F238E27FC236}">
                <a16:creationId xmlns:a16="http://schemas.microsoft.com/office/drawing/2014/main" id="{2D40094A-983E-418C-A521-B2ADDB985678}"/>
              </a:ext>
            </a:extLst>
          </p:cNvPr>
          <p:cNvSpPr/>
          <p:nvPr/>
        </p:nvSpPr>
        <p:spPr>
          <a:xfrm>
            <a:off x="125128" y="1106906"/>
            <a:ext cx="11973828" cy="5544152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F18D476-BB5D-4957-91CA-4A05DA250EED}"/>
              </a:ext>
            </a:extLst>
          </p:cNvPr>
          <p:cNvSpPr txBox="1"/>
          <p:nvPr/>
        </p:nvSpPr>
        <p:spPr>
          <a:xfrm>
            <a:off x="1876934" y="214473"/>
            <a:ext cx="84589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de-DE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ial</a:t>
            </a:r>
            <a:r>
              <a:rPr lang="de-DE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10 </a:t>
            </a:r>
            <a:r>
              <a:rPr lang="de-DE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ngal</a:t>
            </a:r>
            <a:r>
              <a:rPr lang="de-DE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ies</a:t>
            </a:r>
            <a:endParaRPr 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A3587E6A-97A4-44EE-8ACE-1D2FAB501FD6}"/>
              </a:ext>
            </a:extLst>
          </p:cNvPr>
          <p:cNvCxnSpPr>
            <a:stCxn id="84" idx="2"/>
            <a:endCxn id="83" idx="0"/>
          </p:cNvCxnSpPr>
          <p:nvPr/>
        </p:nvCxnSpPr>
        <p:spPr>
          <a:xfrm>
            <a:off x="6106427" y="737693"/>
            <a:ext cx="5615" cy="36921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52997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beca L. Oliva</dc:creator>
  <cp:lastModifiedBy>Rebeca L. Oliva</cp:lastModifiedBy>
  <cp:revision>4</cp:revision>
  <dcterms:created xsi:type="dcterms:W3CDTF">2025-04-03T16:42:27Z</dcterms:created>
  <dcterms:modified xsi:type="dcterms:W3CDTF">2025-04-03T16:55:09Z</dcterms:modified>
</cp:coreProperties>
</file>